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C1502C-2E39-1064-18E6-8AC3F0B103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8ABEC9-5A67-4F6A-69C1-016968FAA8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11BF96-D22F-5C10-3981-66DA0728D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0BB13F-7925-73E5-90C5-8472A33D8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ADF012-BEB3-E863-4C02-67C6D0D24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2665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11BFB-596B-2035-0464-E1B6CEE56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991D04-2EC7-83F2-F461-4CE887FA79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E8521B-4F6F-0D97-33CA-FFB0ACFAA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A22C0-C237-942D-F421-74C0F2E68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08CEA-C51A-5D24-2FB1-279955BB6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3908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197FBF-7B59-621F-D660-05FF0946CA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A93B6B-8A85-5521-E99C-CA16AFA00B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73DE7B-AF0F-0D3D-7BE0-2E1A07DBD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B39932-8944-B3F1-7A27-7381869AF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B23B14-7E82-566F-4230-E479CF03B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4039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CD9BE5-C0A0-6B01-5E56-EB7CB1A0BC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CCCACD-453A-1435-0772-15F18DA3A1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41B4E1-D34E-0DA6-6D4B-529782FEF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DEB456-7EF8-78E7-0D3B-5F92C0DD8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98DA4A-FDA6-7794-1E3C-A3766ED48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1413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FBF74-AD5F-7C52-9812-32970DBD17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399030-D792-ADEA-83AC-D9AC2D7A5C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7284C9-FF75-AF10-4E8B-39A3A2F78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551073-2050-36E1-036B-027FB6206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A0B3F2-7DD6-3CFA-2898-B0F434C08E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7888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C1A910-F5C8-B254-37FE-2FA9564976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4F20F9-2B1A-464E-543D-31DABBE264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067990-8322-3B6F-D58C-E10C3A293B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5B6B6B-46B4-106B-D20C-A37F2229B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430858-6849-E92F-1023-43438DB5B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AAF5E2-BFD4-2AA2-639E-A01625E04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3631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8DF7CF-456E-CEDD-9D5C-C2F867431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71E919-5E9B-39D6-9484-261EF1F073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DD6212-FBEF-88C1-5C3C-9E4EEC57BE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921DA6-74BA-88DD-7752-55C8689442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F55872-D12A-A4BA-8702-324F0ADC0C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EBDDF7-7C9B-D4D3-C070-C72325EF7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74845D-DF91-A4B3-8FAA-44D25371B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5EC25A-9D5E-CA97-8D8F-767E9D920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6791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0E941C-2A71-A46D-B45A-9C211FE76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DBFEBB-BE79-CE5B-4AE1-96E9F2BA6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E03C97-EBDA-707C-19D4-B7E776339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6810B7-FB95-3507-C643-05F6DD43B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523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421D72-4297-D159-DA91-4612A897E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D4E196-261D-72C6-8778-E5F7C8146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C5D434-92A3-3BC0-4B11-58B9A9807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6034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46A84-C72F-85C1-C7D1-552DD2B4B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4292AC-5356-CDE0-A6CF-C327107176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DDA1E4-7D87-CC22-1459-B75159DF56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6068B8-3844-0BFB-A039-7117F7709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ADAC5B-4F10-CCE9-74FE-0D1C30A95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87D42E-939D-D74D-B38E-5189A81D9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3909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19FDC-78FA-10AF-72F7-C6F2E288F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C3603C-3E92-54C7-82DE-6189E6B042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C62CF5-9D13-24B4-D7F2-477F67D75A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182856-1AEC-EA23-AFDD-2FEC548FA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C5D31A-F7C8-648C-DAFC-103771B29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C377C8-3BC0-EF9A-91AB-1802BE5B3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6575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E1157F-4BE2-3606-2523-FAC4506DF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EEC6B5-0F1C-EA81-F65D-F25E60DA0F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536E2D-2DDD-C3ED-6CAD-31B289EB0C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DE4413-7837-48D6-9CF0-05915B1216A0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E1B2F4-F854-4708-7743-AB83DA6AF9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14D96-D570-CA54-1BD5-2406AD2CB9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BA9DDE-B831-45FD-8D07-C92AD2F48C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4764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19F646E-31D8-F064-71C3-BB08602D6E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4672165" y="1479755"/>
            <a:ext cx="2552700" cy="3733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5F36C58-2D49-5BE6-C503-DA7FF8399D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416887" y="1365455"/>
            <a:ext cx="1743075" cy="38481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91A1675-5055-585A-4CF4-6A007E01B6D6}"/>
              </a:ext>
            </a:extLst>
          </p:cNvPr>
          <p:cNvSpPr txBox="1"/>
          <p:nvPr/>
        </p:nvSpPr>
        <p:spPr>
          <a:xfrm>
            <a:off x="1482036" y="2920173"/>
            <a:ext cx="845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CSL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8FF9DB-DCDC-B0FA-C249-66CF3E82FE16}"/>
              </a:ext>
            </a:extLst>
          </p:cNvPr>
          <p:cNvSpPr txBox="1"/>
          <p:nvPr/>
        </p:nvSpPr>
        <p:spPr>
          <a:xfrm>
            <a:off x="2416887" y="996123"/>
            <a:ext cx="61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DFAC17F-F0DF-07C1-8DC9-79EC2C7594E9}"/>
              </a:ext>
            </a:extLst>
          </p:cNvPr>
          <p:cNvSpPr txBox="1"/>
          <p:nvPr/>
        </p:nvSpPr>
        <p:spPr>
          <a:xfrm>
            <a:off x="3029683" y="626791"/>
            <a:ext cx="107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CSL3k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670272B-C73C-13E9-C6BA-D2699631612A}"/>
              </a:ext>
            </a:extLst>
          </p:cNvPr>
          <p:cNvSpPr txBox="1"/>
          <p:nvPr/>
        </p:nvSpPr>
        <p:spPr>
          <a:xfrm>
            <a:off x="3072660" y="99612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B67D317-74CC-96E4-15F0-C3C64114CA72}"/>
              </a:ext>
            </a:extLst>
          </p:cNvPr>
          <p:cNvSpPr txBox="1"/>
          <p:nvPr/>
        </p:nvSpPr>
        <p:spPr>
          <a:xfrm>
            <a:off x="3642479" y="99612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FA4690-66E1-80F8-11BE-302E0374F4BB}"/>
              </a:ext>
            </a:extLst>
          </p:cNvPr>
          <p:cNvSpPr txBox="1"/>
          <p:nvPr/>
        </p:nvSpPr>
        <p:spPr>
          <a:xfrm>
            <a:off x="5527061" y="1110423"/>
            <a:ext cx="61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3271B5-EA0A-2CBC-F394-ACE77D019913}"/>
              </a:ext>
            </a:extLst>
          </p:cNvPr>
          <p:cNvSpPr txBox="1"/>
          <p:nvPr/>
        </p:nvSpPr>
        <p:spPr>
          <a:xfrm>
            <a:off x="6139857" y="741091"/>
            <a:ext cx="107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CSL3k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640C755-9628-4F44-1DC3-0ACBB86AB1FF}"/>
              </a:ext>
            </a:extLst>
          </p:cNvPr>
          <p:cNvSpPr txBox="1"/>
          <p:nvPr/>
        </p:nvSpPr>
        <p:spPr>
          <a:xfrm>
            <a:off x="6182834" y="111042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9A34BFB-2137-B222-239A-54462F363232}"/>
              </a:ext>
            </a:extLst>
          </p:cNvPr>
          <p:cNvSpPr txBox="1"/>
          <p:nvPr/>
        </p:nvSpPr>
        <p:spPr>
          <a:xfrm>
            <a:off x="6752653" y="111042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D18DE3-B4EA-D49A-24BF-224B8078619D}"/>
              </a:ext>
            </a:extLst>
          </p:cNvPr>
          <p:cNvSpPr txBox="1"/>
          <p:nvPr/>
        </p:nvSpPr>
        <p:spPr>
          <a:xfrm>
            <a:off x="4871287" y="787257"/>
            <a:ext cx="93859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rotein </a:t>
            </a:r>
          </a:p>
          <a:p>
            <a:r>
              <a:rPr lang="en-GB" dirty="0"/>
              <a:t>ladd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4B40165-DBBA-DED9-DB0F-31DB52A795A8}"/>
              </a:ext>
            </a:extLst>
          </p:cNvPr>
          <p:cNvSpPr txBox="1"/>
          <p:nvPr/>
        </p:nvSpPr>
        <p:spPr>
          <a:xfrm>
            <a:off x="4298677" y="3799546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5 </a:t>
            </a:r>
            <a:r>
              <a:rPr lang="en-GB" dirty="0" err="1">
                <a:solidFill>
                  <a:schemeClr val="bg1"/>
                </a:solidFill>
              </a:rPr>
              <a:t>kD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A357370-91C5-AB43-53C7-B778DFE657F7}"/>
              </a:ext>
            </a:extLst>
          </p:cNvPr>
          <p:cNvSpPr txBox="1"/>
          <p:nvPr/>
        </p:nvSpPr>
        <p:spPr>
          <a:xfrm>
            <a:off x="4318341" y="4302220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0 </a:t>
            </a:r>
            <a:r>
              <a:rPr lang="en-GB" dirty="0" err="1">
                <a:solidFill>
                  <a:schemeClr val="bg1"/>
                </a:solidFill>
              </a:rPr>
              <a:t>kD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E1F6C62-AE94-CEEC-1504-256DF88F9673}"/>
              </a:ext>
            </a:extLst>
          </p:cNvPr>
          <p:cNvSpPr txBox="1"/>
          <p:nvPr/>
        </p:nvSpPr>
        <p:spPr>
          <a:xfrm>
            <a:off x="4298677" y="4890390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5 </a:t>
            </a:r>
            <a:r>
              <a:rPr lang="en-GB" dirty="0" err="1">
                <a:solidFill>
                  <a:schemeClr val="bg1"/>
                </a:solidFill>
              </a:rPr>
              <a:t>kD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DF60A85-31F1-F58D-EA52-B97E8EA2A03F}"/>
              </a:ext>
            </a:extLst>
          </p:cNvPr>
          <p:cNvSpPr txBox="1"/>
          <p:nvPr/>
        </p:nvSpPr>
        <p:spPr>
          <a:xfrm>
            <a:off x="4194910" y="2708702"/>
            <a:ext cx="99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0 </a:t>
            </a:r>
            <a:r>
              <a:rPr lang="en-GB" dirty="0" err="1">
                <a:solidFill>
                  <a:schemeClr val="bg1"/>
                </a:solidFill>
              </a:rPr>
              <a:t>kD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088E1DB-BF72-06ED-F047-D19A3DD74D71}"/>
              </a:ext>
            </a:extLst>
          </p:cNvPr>
          <p:cNvSpPr txBox="1"/>
          <p:nvPr/>
        </p:nvSpPr>
        <p:spPr>
          <a:xfrm>
            <a:off x="4200357" y="2307752"/>
            <a:ext cx="99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30 </a:t>
            </a:r>
            <a:r>
              <a:rPr lang="en-GB" dirty="0" err="1">
                <a:solidFill>
                  <a:schemeClr val="bg1"/>
                </a:solidFill>
              </a:rPr>
              <a:t>kD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44BB97B-83DE-D3DF-3992-F9FE4FD4784D}"/>
              </a:ext>
            </a:extLst>
          </p:cNvPr>
          <p:cNvSpPr txBox="1"/>
          <p:nvPr/>
        </p:nvSpPr>
        <p:spPr>
          <a:xfrm>
            <a:off x="4205522" y="2056415"/>
            <a:ext cx="99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80 </a:t>
            </a:r>
            <a:r>
              <a:rPr lang="en-GB" dirty="0" err="1">
                <a:solidFill>
                  <a:schemeClr val="bg1"/>
                </a:solidFill>
              </a:rPr>
              <a:t>kD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16748A4-B59C-B375-939A-A8D19DC5958C}"/>
              </a:ext>
            </a:extLst>
          </p:cNvPr>
          <p:cNvSpPr txBox="1"/>
          <p:nvPr/>
        </p:nvSpPr>
        <p:spPr>
          <a:xfrm>
            <a:off x="4318305" y="3059626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70 </a:t>
            </a:r>
            <a:r>
              <a:rPr lang="en-GB" dirty="0" err="1">
                <a:solidFill>
                  <a:schemeClr val="bg1"/>
                </a:solidFill>
              </a:rPr>
              <a:t>kD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F3F4847-6EFD-AB25-43D4-325DF6890DFB}"/>
              </a:ext>
            </a:extLst>
          </p:cNvPr>
          <p:cNvSpPr txBox="1"/>
          <p:nvPr/>
        </p:nvSpPr>
        <p:spPr>
          <a:xfrm>
            <a:off x="4479690" y="5393064"/>
            <a:ext cx="33203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reen: 	ACSL3 antibody signal</a:t>
            </a:r>
          </a:p>
          <a:p>
            <a:r>
              <a:rPr lang="en-GB" dirty="0"/>
              <a:t>Red: 	protein ladder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FA1A8C3-EFD8-D812-D0AD-330CE850C7FF}"/>
              </a:ext>
            </a:extLst>
          </p:cNvPr>
          <p:cNvSpPr/>
          <p:nvPr/>
        </p:nvSpPr>
        <p:spPr>
          <a:xfrm>
            <a:off x="2531340" y="2874677"/>
            <a:ext cx="1584000" cy="444324"/>
          </a:xfrm>
          <a:prstGeom prst="rect">
            <a:avLst/>
          </a:prstGeom>
          <a:noFill/>
          <a:ln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5239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0D7BEDC-D78E-0BA0-6A22-7CC23D2F48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8136"/>
          <a:stretch/>
        </p:blipFill>
        <p:spPr>
          <a:xfrm flipH="1">
            <a:off x="5131551" y="1384383"/>
            <a:ext cx="2126263" cy="37052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91A1675-5055-585A-4CF4-6A007E01B6D6}"/>
              </a:ext>
            </a:extLst>
          </p:cNvPr>
          <p:cNvSpPr txBox="1"/>
          <p:nvPr/>
        </p:nvSpPr>
        <p:spPr>
          <a:xfrm>
            <a:off x="1014803" y="2290241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nc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8FF9DB-DCDC-B0FA-C249-66CF3E82FE16}"/>
              </a:ext>
            </a:extLst>
          </p:cNvPr>
          <p:cNvSpPr txBox="1"/>
          <p:nvPr/>
        </p:nvSpPr>
        <p:spPr>
          <a:xfrm>
            <a:off x="2416887" y="996123"/>
            <a:ext cx="61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DFAC17F-F0DF-07C1-8DC9-79EC2C7594E9}"/>
              </a:ext>
            </a:extLst>
          </p:cNvPr>
          <p:cNvSpPr txBox="1"/>
          <p:nvPr/>
        </p:nvSpPr>
        <p:spPr>
          <a:xfrm>
            <a:off x="3029683" y="626791"/>
            <a:ext cx="107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CSL3k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670272B-C73C-13E9-C6BA-D2699631612A}"/>
              </a:ext>
            </a:extLst>
          </p:cNvPr>
          <p:cNvSpPr txBox="1"/>
          <p:nvPr/>
        </p:nvSpPr>
        <p:spPr>
          <a:xfrm>
            <a:off x="3072660" y="99612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B67D317-74CC-96E4-15F0-C3C64114CA72}"/>
              </a:ext>
            </a:extLst>
          </p:cNvPr>
          <p:cNvSpPr txBox="1"/>
          <p:nvPr/>
        </p:nvSpPr>
        <p:spPr>
          <a:xfrm>
            <a:off x="3642479" y="99612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FA4690-66E1-80F8-11BE-302E0374F4BB}"/>
              </a:ext>
            </a:extLst>
          </p:cNvPr>
          <p:cNvSpPr txBox="1"/>
          <p:nvPr/>
        </p:nvSpPr>
        <p:spPr>
          <a:xfrm>
            <a:off x="5527061" y="1080927"/>
            <a:ext cx="61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3271B5-EA0A-2CBC-F394-ACE77D019913}"/>
              </a:ext>
            </a:extLst>
          </p:cNvPr>
          <p:cNvSpPr txBox="1"/>
          <p:nvPr/>
        </p:nvSpPr>
        <p:spPr>
          <a:xfrm>
            <a:off x="6139857" y="711595"/>
            <a:ext cx="107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CSL3k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640C755-9628-4F44-1DC3-0ACBB86AB1FF}"/>
              </a:ext>
            </a:extLst>
          </p:cNvPr>
          <p:cNvSpPr txBox="1"/>
          <p:nvPr/>
        </p:nvSpPr>
        <p:spPr>
          <a:xfrm>
            <a:off x="6182834" y="1080927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9A34BFB-2137-B222-239A-54462F363232}"/>
              </a:ext>
            </a:extLst>
          </p:cNvPr>
          <p:cNvSpPr txBox="1"/>
          <p:nvPr/>
        </p:nvSpPr>
        <p:spPr>
          <a:xfrm>
            <a:off x="6752653" y="1080927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D18DE3-B4EA-D49A-24BF-224B8078619D}"/>
              </a:ext>
            </a:extLst>
          </p:cNvPr>
          <p:cNvSpPr txBox="1"/>
          <p:nvPr/>
        </p:nvSpPr>
        <p:spPr>
          <a:xfrm>
            <a:off x="4871287" y="757761"/>
            <a:ext cx="93859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rotein </a:t>
            </a:r>
          </a:p>
          <a:p>
            <a:r>
              <a:rPr lang="en-GB" dirty="0"/>
              <a:t>ladd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4B40165-DBBA-DED9-DB0F-31DB52A795A8}"/>
              </a:ext>
            </a:extLst>
          </p:cNvPr>
          <p:cNvSpPr txBox="1"/>
          <p:nvPr/>
        </p:nvSpPr>
        <p:spPr>
          <a:xfrm>
            <a:off x="4298677" y="3799546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A357370-91C5-AB43-53C7-B778DFE657F7}"/>
              </a:ext>
            </a:extLst>
          </p:cNvPr>
          <p:cNvSpPr txBox="1"/>
          <p:nvPr/>
        </p:nvSpPr>
        <p:spPr>
          <a:xfrm>
            <a:off x="4318341" y="4302220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E1F6C62-AE94-CEEC-1504-256DF88F9673}"/>
              </a:ext>
            </a:extLst>
          </p:cNvPr>
          <p:cNvSpPr txBox="1"/>
          <p:nvPr/>
        </p:nvSpPr>
        <p:spPr>
          <a:xfrm>
            <a:off x="4298677" y="4890390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DF60A85-31F1-F58D-EA52-B97E8EA2A03F}"/>
              </a:ext>
            </a:extLst>
          </p:cNvPr>
          <p:cNvSpPr txBox="1"/>
          <p:nvPr/>
        </p:nvSpPr>
        <p:spPr>
          <a:xfrm>
            <a:off x="4194910" y="2708702"/>
            <a:ext cx="99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088E1DB-BF72-06ED-F047-D19A3DD74D71}"/>
              </a:ext>
            </a:extLst>
          </p:cNvPr>
          <p:cNvSpPr txBox="1"/>
          <p:nvPr/>
        </p:nvSpPr>
        <p:spPr>
          <a:xfrm>
            <a:off x="4200357" y="2337248"/>
            <a:ext cx="99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3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44BB97B-83DE-D3DF-3992-F9FE4FD4784D}"/>
              </a:ext>
            </a:extLst>
          </p:cNvPr>
          <p:cNvSpPr txBox="1"/>
          <p:nvPr/>
        </p:nvSpPr>
        <p:spPr>
          <a:xfrm>
            <a:off x="4205522" y="2105575"/>
            <a:ext cx="99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8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16748A4-B59C-B375-939A-A8D19DC5958C}"/>
              </a:ext>
            </a:extLst>
          </p:cNvPr>
          <p:cNvSpPr txBox="1"/>
          <p:nvPr/>
        </p:nvSpPr>
        <p:spPr>
          <a:xfrm>
            <a:off x="4318305" y="3059626"/>
            <a:ext cx="872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7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F3F4847-6EFD-AB25-43D4-325DF6890DFB}"/>
              </a:ext>
            </a:extLst>
          </p:cNvPr>
          <p:cNvSpPr txBox="1"/>
          <p:nvPr/>
        </p:nvSpPr>
        <p:spPr>
          <a:xfrm>
            <a:off x="4479690" y="5393064"/>
            <a:ext cx="5036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reen: 	ACSL3 antibody signal, protein ladder</a:t>
            </a:r>
          </a:p>
          <a:p>
            <a:r>
              <a:rPr lang="en-GB" dirty="0"/>
              <a:t>Red: 	vinculin antibody signal, protein ladde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6C4213E-E4D1-5707-9D35-57971992AD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1874028" y="1415783"/>
            <a:ext cx="2190750" cy="3676650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845C6158-5F48-9351-C931-C870E9D4F2D5}"/>
              </a:ext>
            </a:extLst>
          </p:cNvPr>
          <p:cNvSpPr/>
          <p:nvPr/>
        </p:nvSpPr>
        <p:spPr>
          <a:xfrm>
            <a:off x="2450927" y="2272088"/>
            <a:ext cx="1584000" cy="444324"/>
          </a:xfrm>
          <a:prstGeom prst="rect">
            <a:avLst/>
          </a:prstGeom>
          <a:noFill/>
          <a:ln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7822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87</Words>
  <Application>Microsoft Office PowerPoint</Application>
  <PresentationFormat>Widescreen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2</cp:revision>
  <dcterms:created xsi:type="dcterms:W3CDTF">2024-06-18T14:19:18Z</dcterms:created>
  <dcterms:modified xsi:type="dcterms:W3CDTF">2024-06-18T14:35:11Z</dcterms:modified>
</cp:coreProperties>
</file>